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3FFFE8E-DBA2-4AE8-8507-A74025C024FD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A5B5C81-0F35-4250-896A-B1729693FA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D9D9FC7-3D02-4AD0-96B7-F082610C82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A1FD8D6-9F3B-4A98-A055-3639F39EFC04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2A0F819-5A8C-4708-B003-1EEA54282C1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E10F835-7B45-4F68-BEF8-46DC762DC1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017BE47-4E1B-478E-B480-64810296A8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702666B-37EB-4100-911E-6CC8226359F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680"/>
            <a:ext cx="8228160" cy="529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BC3DC71-B619-46C5-8545-D994FE6763A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47A0466-316D-48AD-98F7-222DD12649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28B500B-4117-4C0F-BED0-3788117360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FA69237-09D1-4449-97F7-FADC6AC3A2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7200" y="6353280"/>
            <a:ext cx="2131920" cy="37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date/time&gt;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"/>
          <p:cNvSpPr/>
          <p:nvPr/>
        </p:nvSpPr>
        <p:spPr>
          <a:xfrm>
            <a:off x="3124080" y="6354720"/>
            <a:ext cx="289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6552720" y="6353280"/>
            <a:ext cx="2132280" cy="37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fld id="{4D58B530-D4ED-42ED-BF06-AB2BDF27EC05}" type="slidenum"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5" Type="http://schemas.openxmlformats.org/officeDocument/2006/relationships/image" Target="../media/image12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576520" y="1066680"/>
            <a:ext cx="2971800" cy="533520"/>
          </a:xfrm>
          <a:prstGeom prst="rect">
            <a:avLst/>
          </a:prstGeom>
          <a:noFill/>
          <a:ln cap="sq"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rticipants visited the Free Health Camps (n=275)(m=126) (f=149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2" name=""/>
          <p:cNvCxnSpPr/>
          <p:nvPr/>
        </p:nvCxnSpPr>
        <p:spPr>
          <a:xfrm>
            <a:off x="3968280" y="1600200"/>
            <a:ext cx="2520" cy="2667240"/>
          </a:xfrm>
          <a:prstGeom prst="straightConnector1">
            <a:avLst/>
          </a:prstGeom>
          <a:ln cap="sq"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3" name=""/>
          <p:cNvSpPr/>
          <p:nvPr/>
        </p:nvSpPr>
        <p:spPr>
          <a:xfrm>
            <a:off x="4672080" y="1981080"/>
            <a:ext cx="3146400" cy="1676520"/>
          </a:xfrm>
          <a:prstGeom prst="rect">
            <a:avLst/>
          </a:prstGeom>
          <a:noFill/>
          <a:ln cap="sq"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rticipants Excluded (n=37, 13.45%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−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iabetics  (n=2, 0.72%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−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CV (n=5, 1.81%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−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stprandial (n= 30, 10.90%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4" name=""/>
          <p:cNvCxnSpPr/>
          <p:nvPr/>
        </p:nvCxnSpPr>
        <p:spPr>
          <a:xfrm>
            <a:off x="3968640" y="2728440"/>
            <a:ext cx="705240" cy="2520"/>
          </a:xfrm>
          <a:prstGeom prst="straightConnector1">
            <a:avLst/>
          </a:prstGeom>
          <a:ln cap="sq"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5" name=""/>
          <p:cNvSpPr/>
          <p:nvPr/>
        </p:nvSpPr>
        <p:spPr>
          <a:xfrm>
            <a:off x="2728800" y="4267080"/>
            <a:ext cx="3733920" cy="609840"/>
          </a:xfrm>
          <a:prstGeom prst="rect">
            <a:avLst/>
          </a:prstGeom>
          <a:noFill/>
          <a:ln cap="sq"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rticipants included in the final analysi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n=238) (dyslipidemic=149) (non-dyslipidemic=89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"/>
          <p:cNvSpPr/>
          <p:nvPr/>
        </p:nvSpPr>
        <p:spPr>
          <a:xfrm>
            <a:off x="-14400" y="0"/>
            <a:ext cx="1906560" cy="261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Figure S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"/>
          <p:cNvSpPr/>
          <p:nvPr/>
        </p:nvSpPr>
        <p:spPr>
          <a:xfrm>
            <a:off x="436680" y="5181480"/>
            <a:ext cx="847224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 -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nrolment flowchart of the study population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275 participants visited the free health camps. 37 participants were excluded because of HCV diagnosis (n=5), Postprandial state (n=30) and Diabetes (n=2). The final group sample consisted of 238 participant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/>
          <p:nvPr/>
        </p:nvSpPr>
        <p:spPr>
          <a:xfrm>
            <a:off x="-14400" y="0"/>
            <a:ext cx="1906560" cy="261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Figure S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9" name=""/>
          <p:cNvGrpSpPr/>
          <p:nvPr/>
        </p:nvGrpSpPr>
        <p:grpSpPr>
          <a:xfrm>
            <a:off x="1892160" y="380880"/>
            <a:ext cx="4811760" cy="4543560"/>
            <a:chOff x="1892160" y="380880"/>
            <a:chExt cx="4811760" cy="4543560"/>
          </a:xfrm>
        </p:grpSpPr>
        <p:pic>
          <p:nvPicPr>
            <p:cNvPr id="50" name="" descr=""/>
            <p:cNvPicPr/>
            <p:nvPr/>
          </p:nvPicPr>
          <p:blipFill>
            <a:blip r:embed="rId1"/>
            <a:stretch/>
          </p:blipFill>
          <p:spPr>
            <a:xfrm>
              <a:off x="5353200" y="2365200"/>
              <a:ext cx="1350720" cy="7779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1" name=""/>
            <p:cNvGrpSpPr/>
            <p:nvPr/>
          </p:nvGrpSpPr>
          <p:grpSpPr>
            <a:xfrm>
              <a:off x="1892160" y="380880"/>
              <a:ext cx="3926160" cy="3557880"/>
              <a:chOff x="1892160" y="380880"/>
              <a:chExt cx="3926160" cy="3557880"/>
            </a:xfrm>
          </p:grpSpPr>
          <p:sp>
            <p:nvSpPr>
              <p:cNvPr id="52" name=""/>
              <p:cNvSpPr/>
              <p:nvPr/>
            </p:nvSpPr>
            <p:spPr>
              <a:xfrm>
                <a:off x="3790800" y="2236680"/>
                <a:ext cx="1260720" cy="1206720"/>
              </a:xfrm>
              <a:prstGeom prst="ellipse">
                <a:avLst/>
              </a:prstGeom>
              <a:solidFill>
                <a:srgbClr val="5bf331">
                  <a:alpha val="50000"/>
                </a:srgbClr>
              </a:solidFill>
              <a:ln cap="sq" w="3240">
                <a:solidFill>
                  <a:srgbClr val="83f664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2681280" y="830160"/>
                <a:ext cx="2219400" cy="2124000"/>
              </a:xfrm>
              <a:prstGeom prst="ellipse">
                <a:avLst/>
              </a:prstGeom>
              <a:solidFill>
                <a:srgbClr val="fffe00">
                  <a:alpha val="42000"/>
                </a:srgbClr>
              </a:solidFill>
              <a:ln cap="sq" w="3240">
                <a:solidFill>
                  <a:srgbClr val="ffe79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2612880" y="2182680"/>
                <a:ext cx="1836720" cy="1756080"/>
              </a:xfrm>
              <a:prstGeom prst="ellipse">
                <a:avLst/>
              </a:prstGeom>
              <a:solidFill>
                <a:srgbClr val="00b0f0">
                  <a:alpha val="34000"/>
                </a:srgbClr>
              </a:solidFill>
              <a:ln cap="sq" w="3240">
                <a:solidFill>
                  <a:srgbClr val="00b0f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2173320" y="1092240"/>
                <a:ext cx="944640" cy="428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333080"/>
                    <a:tab algn="l" pos="10782360"/>
                  </a:tabLst>
                </a:pPr>
                <a:r>
                  <a:rPr b="1" lang="en-GB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ow HDL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333080"/>
                    <a:tab algn="l" pos="10782360"/>
                  </a:tabLst>
                </a:pPr>
                <a:r>
                  <a:rPr b="1" lang="en-GB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  </a:t>
                </a:r>
                <a:r>
                  <a:rPr b="1" lang="en-GB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n=93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1892160" y="3459240"/>
                <a:ext cx="816120" cy="428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333080"/>
                    <a:tab algn="l" pos="10782360"/>
                  </a:tabLst>
                </a:pPr>
                <a:r>
                  <a:rPr b="1" lang="en-GB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High TG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333080"/>
                    <a:tab algn="l" pos="10782360"/>
                  </a:tabLst>
                </a:pPr>
                <a:r>
                  <a:rPr b="1" lang="en-GB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</a:t>
                </a:r>
                <a:r>
                  <a:rPr b="1" lang="en-GB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n=76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4978440" y="2849400"/>
                <a:ext cx="839880" cy="428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333080"/>
                    <a:tab algn="l" pos="10782360"/>
                  </a:tabLst>
                </a:pPr>
                <a:r>
                  <a:rPr b="1" lang="en-GB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High LDL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333080"/>
                    <a:tab algn="l" pos="10782360"/>
                  </a:tabLst>
                </a:pPr>
                <a:r>
                  <a:rPr b="1" lang="en-GB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    </a:t>
                </a:r>
                <a:r>
                  <a:rPr b="1" lang="en-GB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n=53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3112920" y="2416320"/>
                <a:ext cx="10749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333080"/>
                    <a:tab algn="l" pos="10782360"/>
                  </a:tabLst>
                </a:pPr>
                <a:r>
                  <a:rPr b="1" lang="en-GB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1 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2955960" y="3200400"/>
                <a:ext cx="9842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333080"/>
                    <a:tab algn="l" pos="10782360"/>
                  </a:tabLst>
                </a:pPr>
                <a:r>
                  <a:rPr b="1" lang="en-GB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33 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3619440" y="3017880"/>
                <a:ext cx="11541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333080"/>
                    <a:tab algn="l" pos="10782360"/>
                  </a:tabLst>
                </a:pPr>
                <a:r>
                  <a:rPr b="1" lang="en-GB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9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3478320" y="2603520"/>
                <a:ext cx="12240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333080"/>
                    <a:tab algn="l" pos="10782360"/>
                  </a:tabLst>
                </a:pPr>
                <a:r>
                  <a:rPr b="1" lang="en-GB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3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3890880" y="2306520"/>
                <a:ext cx="11732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333080"/>
                    <a:tab algn="l" pos="10782360"/>
                  </a:tabLst>
                </a:pPr>
                <a:r>
                  <a:rPr b="1" lang="en-GB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8 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3343320" y="1285920"/>
                <a:ext cx="10144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333080"/>
                    <a:tab algn="l" pos="10782360"/>
                  </a:tabLst>
                </a:pPr>
                <a:r>
                  <a:rPr b="1" lang="en-GB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41 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4149720" y="2852640"/>
                <a:ext cx="12240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333080"/>
                    <a:tab algn="l" pos="10782360"/>
                  </a:tabLst>
                </a:pPr>
                <a:r>
                  <a:rPr b="1" lang="en-GB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4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4660920" y="380880"/>
                <a:ext cx="712800" cy="261360"/>
              </a:xfrm>
              <a:prstGeom prst="rect">
                <a:avLst/>
              </a:prstGeom>
              <a:noFill/>
              <a:ln cap="sq" w="9360">
                <a:solidFill>
                  <a:srgbClr val="000000"/>
                </a:solidFill>
                <a:custDash>
                  <a:ds d="400000" sp="300000"/>
                </a:custDash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333080"/>
                    <a:tab algn="l" pos="10782360"/>
                  </a:tabLst>
                </a:pPr>
                <a:r>
                  <a:rPr b="1" lang="en-GB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n=149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6" name=""/>
            <p:cNvSpPr/>
            <p:nvPr/>
          </p:nvSpPr>
          <p:spPr>
            <a:xfrm>
              <a:off x="4189320" y="1000080"/>
              <a:ext cx="1649520" cy="0"/>
            </a:xfrm>
            <a:prstGeom prst="line">
              <a:avLst/>
            </a:prstGeom>
            <a:ln cap="sq" w="3240">
              <a:solidFill>
                <a:srgbClr val="d99694"/>
              </a:solidFill>
              <a:custDash>
                <a:ds d="400000" sp="300000"/>
              </a:custDash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7" name="" descr=""/>
            <p:cNvPicPr/>
            <p:nvPr/>
          </p:nvPicPr>
          <p:blipFill>
            <a:blip r:embed="rId2"/>
            <a:stretch/>
          </p:blipFill>
          <p:spPr>
            <a:xfrm>
              <a:off x="5321160" y="2998800"/>
              <a:ext cx="1357560" cy="766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" descr=""/>
            <p:cNvPicPr/>
            <p:nvPr/>
          </p:nvPicPr>
          <p:blipFill>
            <a:blip r:embed="rId3"/>
            <a:stretch/>
          </p:blipFill>
          <p:spPr>
            <a:xfrm>
              <a:off x="5321160" y="4157640"/>
              <a:ext cx="1351080" cy="766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" descr=""/>
            <p:cNvPicPr/>
            <p:nvPr/>
          </p:nvPicPr>
          <p:blipFill>
            <a:blip r:embed="rId4"/>
            <a:stretch/>
          </p:blipFill>
          <p:spPr>
            <a:xfrm>
              <a:off x="5310360" y="1170000"/>
              <a:ext cx="1357200" cy="766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" descr=""/>
            <p:cNvPicPr/>
            <p:nvPr/>
          </p:nvPicPr>
          <p:blipFill>
            <a:blip r:embed="rId5"/>
            <a:stretch/>
          </p:blipFill>
          <p:spPr>
            <a:xfrm>
              <a:off x="5321160" y="3584520"/>
              <a:ext cx="1351080" cy="766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" descr=""/>
            <p:cNvPicPr/>
            <p:nvPr/>
          </p:nvPicPr>
          <p:blipFill>
            <a:blip r:embed="rId6"/>
            <a:stretch/>
          </p:blipFill>
          <p:spPr>
            <a:xfrm>
              <a:off x="5321160" y="579600"/>
              <a:ext cx="1351080" cy="772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2" name="" descr=""/>
            <p:cNvPicPr/>
            <p:nvPr/>
          </p:nvPicPr>
          <p:blipFill>
            <a:blip r:embed="rId7"/>
            <a:stretch/>
          </p:blipFill>
          <p:spPr>
            <a:xfrm>
              <a:off x="5321160" y="1762200"/>
              <a:ext cx="1351080" cy="77292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73" name=""/>
          <p:cNvGrpSpPr/>
          <p:nvPr/>
        </p:nvGrpSpPr>
        <p:grpSpPr>
          <a:xfrm>
            <a:off x="7086600" y="3994200"/>
            <a:ext cx="1003320" cy="491400"/>
            <a:chOff x="7086600" y="3994200"/>
            <a:chExt cx="1003320" cy="491400"/>
          </a:xfrm>
        </p:grpSpPr>
        <p:grpSp>
          <p:nvGrpSpPr>
            <p:cNvPr id="74" name=""/>
            <p:cNvGrpSpPr/>
            <p:nvPr/>
          </p:nvGrpSpPr>
          <p:grpSpPr>
            <a:xfrm>
              <a:off x="7086600" y="4033800"/>
              <a:ext cx="176040" cy="379080"/>
              <a:chOff x="7086600" y="4033800"/>
              <a:chExt cx="176040" cy="379080"/>
            </a:xfrm>
          </p:grpSpPr>
          <p:sp>
            <p:nvSpPr>
              <p:cNvPr id="75" name=""/>
              <p:cNvSpPr/>
              <p:nvPr/>
            </p:nvSpPr>
            <p:spPr>
              <a:xfrm>
                <a:off x="7086600" y="4033800"/>
                <a:ext cx="176040" cy="150120"/>
              </a:xfrm>
              <a:prstGeom prst="rect">
                <a:avLst/>
              </a:prstGeom>
              <a:solidFill>
                <a:srgbClr val="558ed5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7086600" y="4263120"/>
                <a:ext cx="176040" cy="149760"/>
              </a:xfrm>
              <a:prstGeom prst="rect">
                <a:avLst/>
              </a:prstGeom>
              <a:solidFill>
                <a:srgbClr val="d9969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7" name=""/>
            <p:cNvSpPr/>
            <p:nvPr/>
          </p:nvSpPr>
          <p:spPr>
            <a:xfrm>
              <a:off x="7245360" y="3994200"/>
              <a:ext cx="844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ales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7238880" y="4224240"/>
              <a:ext cx="844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emales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9" name=""/>
          <p:cNvSpPr/>
          <p:nvPr/>
        </p:nvSpPr>
        <p:spPr>
          <a:xfrm>
            <a:off x="4118040" y="1468440"/>
            <a:ext cx="1558800" cy="1440"/>
          </a:xfrm>
          <a:prstGeom prst="line">
            <a:avLst/>
          </a:prstGeom>
          <a:ln cap="sq" w="3240">
            <a:solidFill>
              <a:srgbClr val="d99694"/>
            </a:solidFill>
            <a:custDash>
              <a:ds d="400000" sp="300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"/>
          <p:cNvSpPr/>
          <p:nvPr/>
        </p:nvSpPr>
        <p:spPr>
          <a:xfrm flipH="1">
            <a:off x="3726000" y="1468440"/>
            <a:ext cx="380880" cy="771480"/>
          </a:xfrm>
          <a:prstGeom prst="line">
            <a:avLst/>
          </a:prstGeom>
          <a:ln cap="sq" w="3240">
            <a:solidFill>
              <a:srgbClr val="d99694"/>
            </a:solidFill>
            <a:custDash>
              <a:ds d="400000" sp="300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"/>
          <p:cNvSpPr/>
          <p:nvPr/>
        </p:nvSpPr>
        <p:spPr>
          <a:xfrm>
            <a:off x="4233960" y="2652840"/>
            <a:ext cx="1557360" cy="1440"/>
          </a:xfrm>
          <a:prstGeom prst="line">
            <a:avLst/>
          </a:prstGeom>
          <a:ln cap="sq" w="3240">
            <a:solidFill>
              <a:srgbClr val="d99694"/>
            </a:solidFill>
            <a:custDash>
              <a:ds d="400000" sp="300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"/>
          <p:cNvSpPr/>
          <p:nvPr/>
        </p:nvSpPr>
        <p:spPr>
          <a:xfrm>
            <a:off x="4191120" y="3886200"/>
            <a:ext cx="1619280" cy="1440"/>
          </a:xfrm>
          <a:prstGeom prst="line">
            <a:avLst/>
          </a:prstGeom>
          <a:ln cap="sq" w="3240">
            <a:solidFill>
              <a:srgbClr val="d99694"/>
            </a:solidFill>
            <a:custDash>
              <a:ds d="400000" sp="300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"/>
          <p:cNvSpPr/>
          <p:nvPr/>
        </p:nvSpPr>
        <p:spPr>
          <a:xfrm flipV="1">
            <a:off x="4191120" y="3274560"/>
            <a:ext cx="1440" cy="615960"/>
          </a:xfrm>
          <a:prstGeom prst="line">
            <a:avLst/>
          </a:prstGeom>
          <a:ln cap="sq" w="3240">
            <a:solidFill>
              <a:srgbClr val="d99694"/>
            </a:solidFill>
            <a:custDash>
              <a:ds d="400000" sp="300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"/>
          <p:cNvSpPr/>
          <p:nvPr/>
        </p:nvSpPr>
        <p:spPr>
          <a:xfrm>
            <a:off x="4687920" y="3276720"/>
            <a:ext cx="1114560" cy="1440"/>
          </a:xfrm>
          <a:prstGeom prst="line">
            <a:avLst/>
          </a:prstGeom>
          <a:ln cap="sq" w="3240">
            <a:solidFill>
              <a:srgbClr val="d99694"/>
            </a:solidFill>
            <a:custDash>
              <a:ds d="400000" sp="300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"/>
          <p:cNvSpPr/>
          <p:nvPr/>
        </p:nvSpPr>
        <p:spPr>
          <a:xfrm>
            <a:off x="3801960" y="4287960"/>
            <a:ext cx="1957320" cy="1440"/>
          </a:xfrm>
          <a:prstGeom prst="line">
            <a:avLst/>
          </a:prstGeom>
          <a:ln cap="sq" w="3240">
            <a:solidFill>
              <a:srgbClr val="d99694"/>
            </a:solidFill>
            <a:custDash>
              <a:ds d="400000" sp="300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"/>
          <p:cNvSpPr/>
          <p:nvPr/>
        </p:nvSpPr>
        <p:spPr>
          <a:xfrm flipV="1">
            <a:off x="3803760" y="3709800"/>
            <a:ext cx="1440" cy="569880"/>
          </a:xfrm>
          <a:prstGeom prst="line">
            <a:avLst/>
          </a:prstGeom>
          <a:ln cap="sq" w="3240">
            <a:solidFill>
              <a:srgbClr val="d99694"/>
            </a:solidFill>
            <a:custDash>
              <a:ds d="400000" sp="300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"/>
          <p:cNvSpPr/>
          <p:nvPr/>
        </p:nvSpPr>
        <p:spPr>
          <a:xfrm>
            <a:off x="4363920" y="2147760"/>
            <a:ext cx="1557360" cy="1800"/>
          </a:xfrm>
          <a:prstGeom prst="line">
            <a:avLst/>
          </a:prstGeom>
          <a:ln cap="sq" w="3240">
            <a:solidFill>
              <a:srgbClr val="d99694"/>
            </a:solidFill>
            <a:custDash>
              <a:ds d="400000" sp="300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"/>
          <p:cNvSpPr/>
          <p:nvPr/>
        </p:nvSpPr>
        <p:spPr>
          <a:xfrm>
            <a:off x="433440" y="5181480"/>
            <a:ext cx="8177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 -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nn-Diagram displays overlaps between prevalence of high LDL, TG and low HDL levels in the dyslipidemic population.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"/>
          <p:cNvSpPr/>
          <p:nvPr/>
        </p:nvSpPr>
        <p:spPr>
          <a:xfrm>
            <a:off x="76320" y="2633760"/>
            <a:ext cx="457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"/>
          <p:cNvSpPr/>
          <p:nvPr/>
        </p:nvSpPr>
        <p:spPr>
          <a:xfrm>
            <a:off x="2971800" y="2600280"/>
            <a:ext cx="457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"/>
          <p:cNvSpPr/>
          <p:nvPr/>
        </p:nvSpPr>
        <p:spPr>
          <a:xfrm>
            <a:off x="1219320" y="5605560"/>
            <a:ext cx="457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d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"/>
          <p:cNvSpPr/>
          <p:nvPr/>
        </p:nvSpPr>
        <p:spPr>
          <a:xfrm>
            <a:off x="4267080" y="5605560"/>
            <a:ext cx="457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e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3" name=""/>
          <p:cNvGrpSpPr/>
          <p:nvPr/>
        </p:nvGrpSpPr>
        <p:grpSpPr>
          <a:xfrm>
            <a:off x="0" y="352440"/>
            <a:ext cx="7267680" cy="5742000"/>
            <a:chOff x="0" y="352440"/>
            <a:chExt cx="7267680" cy="5742000"/>
          </a:xfrm>
        </p:grpSpPr>
        <p:pic>
          <p:nvPicPr>
            <p:cNvPr id="94" name="" descr=""/>
            <p:cNvPicPr/>
            <p:nvPr/>
          </p:nvPicPr>
          <p:blipFill>
            <a:blip r:embed="rId1"/>
            <a:srcRect l="4068" t="6119" r="25664" b="7289"/>
            <a:stretch/>
          </p:blipFill>
          <p:spPr>
            <a:xfrm>
              <a:off x="0" y="352440"/>
              <a:ext cx="3043080" cy="2741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5" name="" descr=""/>
            <p:cNvPicPr/>
            <p:nvPr/>
          </p:nvPicPr>
          <p:blipFill>
            <a:blip r:embed="rId2"/>
            <a:srcRect l="4747" t="6104" r="25225" b="7537"/>
            <a:stretch/>
          </p:blipFill>
          <p:spPr>
            <a:xfrm>
              <a:off x="3051000" y="380880"/>
              <a:ext cx="3043440" cy="2741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6" name="" descr=""/>
            <p:cNvPicPr/>
            <p:nvPr/>
          </p:nvPicPr>
          <p:blipFill>
            <a:blip r:embed="rId3"/>
            <a:srcRect l="4591" t="6104" r="25448" b="7537"/>
            <a:stretch/>
          </p:blipFill>
          <p:spPr>
            <a:xfrm>
              <a:off x="0" y="3344760"/>
              <a:ext cx="3043080" cy="2741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7" name="" descr=""/>
            <p:cNvPicPr/>
            <p:nvPr/>
          </p:nvPicPr>
          <p:blipFill>
            <a:blip r:embed="rId4"/>
            <a:srcRect l="3563" t="6119" r="25598" b="7289"/>
            <a:stretch/>
          </p:blipFill>
          <p:spPr>
            <a:xfrm>
              <a:off x="3033720" y="3352680"/>
              <a:ext cx="3043080" cy="2741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8" name="" descr=""/>
            <p:cNvPicPr/>
            <p:nvPr/>
          </p:nvPicPr>
          <p:blipFill>
            <a:blip r:embed="rId5"/>
            <a:srcRect l="74228" t="6464" r="8971" b="36025"/>
            <a:stretch/>
          </p:blipFill>
          <p:spPr>
            <a:xfrm>
              <a:off x="6373800" y="430200"/>
              <a:ext cx="893880" cy="24192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99" name=""/>
          <p:cNvSpPr/>
          <p:nvPr/>
        </p:nvSpPr>
        <p:spPr>
          <a:xfrm>
            <a:off x="-14400" y="0"/>
            <a:ext cx="1766880" cy="261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Figure S3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"/>
          <p:cNvSpPr/>
          <p:nvPr/>
        </p:nvSpPr>
        <p:spPr>
          <a:xfrm>
            <a:off x="152280" y="2852640"/>
            <a:ext cx="457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"/>
          <p:cNvSpPr/>
          <p:nvPr/>
        </p:nvSpPr>
        <p:spPr>
          <a:xfrm>
            <a:off x="3048120" y="2819520"/>
            <a:ext cx="457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"/>
          <p:cNvSpPr/>
          <p:nvPr/>
        </p:nvSpPr>
        <p:spPr>
          <a:xfrm>
            <a:off x="158760" y="5884920"/>
            <a:ext cx="457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c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"/>
          <p:cNvSpPr/>
          <p:nvPr/>
        </p:nvSpPr>
        <p:spPr>
          <a:xfrm flipH="1">
            <a:off x="3064680" y="5884920"/>
            <a:ext cx="585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d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"/>
          <p:cNvSpPr/>
          <p:nvPr/>
        </p:nvSpPr>
        <p:spPr>
          <a:xfrm>
            <a:off x="152280" y="6135840"/>
            <a:ext cx="883944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– Receiver operating characteristic (ROC) curve analysis to determine the predictive capability of different anthropometric/metabolic parameters for identification of (a) Overall Dyslipidemia (irregularity in the plasma levels of HDL, LDL or Triglycerides (b) Low-HDL levels (c) High-LDL and (d) High-TG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3-06T06:42:30Z</dcterms:created>
  <dc:creator>Dr Nousheen Zaidi</dc:creator>
  <dc:description/>
  <dc:language>en-US</dc:language>
  <cp:lastModifiedBy>Dr Nousheen Zaidi</cp:lastModifiedBy>
  <dcterms:modified xsi:type="dcterms:W3CDTF">2017-01-27T09:00:20Z</dcterms:modified>
  <cp:revision>29</cp:revision>
  <dc:subject/>
  <dc:title>PowerPoint Presentation</dc:title>
</cp:coreProperties>
</file>